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144000" cy="6858000"/>
  <p:notesSz cx="7008813" cy="92948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7009200" cy="92952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Calibri"/>
            </a:endParaRPr>
          </a:p>
        </p:txBody>
      </p:sp>
      <p:sp>
        <p:nvSpPr>
          <p:cNvPr id="42" name="PlaceHolder 1"/>
          <p:cNvSpPr>
            <a:spLocks noGrp="1"/>
          </p:cNvSpPr>
          <p:nvPr>
            <p:ph type="hdr"/>
          </p:nvPr>
        </p:nvSpPr>
        <p:spPr>
          <a:xfrm>
            <a:off x="0" y="0"/>
            <a:ext cx="3036960" cy="463680"/>
          </a:xfrm>
          <a:prstGeom prst="rect">
            <a:avLst/>
          </a:prstGeom>
          <a:noFill/>
          <a:ln w="0">
            <a:noFill/>
          </a:ln>
        </p:spPr>
        <p:txBody>
          <a:bodyPr lIns="90720" rIns="90720" tIns="45360" bIns="4536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 name="PlaceHolder 2"/>
          <p:cNvSpPr>
            <a:spLocks noGrp="1"/>
          </p:cNvSpPr>
          <p:nvPr>
            <p:ph type="dt" idx="4"/>
          </p:nvPr>
        </p:nvSpPr>
        <p:spPr>
          <a:xfrm>
            <a:off x="3971880" y="0"/>
            <a:ext cx="3036960" cy="463680"/>
          </a:xfrm>
          <a:prstGeom prst="rect">
            <a:avLst/>
          </a:prstGeom>
          <a:noFill/>
          <a:ln w="0">
            <a:noFill/>
          </a:ln>
        </p:spPr>
        <p:txBody>
          <a:bodyPr lIns="90720" rIns="90720" tIns="45360" bIns="4536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Calibri"/>
            </a:endParaRPr>
          </a:p>
        </p:txBody>
      </p:sp>
      <p:sp>
        <p:nvSpPr>
          <p:cNvPr id="44" name="PlaceHolder 3"/>
          <p:cNvSpPr>
            <a:spLocks noGrp="1"/>
          </p:cNvSpPr>
          <p:nvPr>
            <p:ph type="sldImg"/>
          </p:nvPr>
        </p:nvSpPr>
        <p:spPr>
          <a:xfrm>
            <a:off x="1179000" y="696960"/>
            <a:ext cx="4651560" cy="3487680"/>
          </a:xfrm>
          <a:prstGeom prst="rect">
            <a:avLst/>
          </a:prstGeom>
          <a:noFill/>
          <a:ln w="12600">
            <a:solidFill>
              <a:srgbClr val="000000"/>
            </a:solidFill>
            <a:miter/>
          </a:ln>
        </p:spPr>
        <p:txBody>
          <a:bodyPr lIns="90720" rIns="90720" tIns="45360" bIns="453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701280" y="4416120"/>
            <a:ext cx="5607000" cy="4182840"/>
          </a:xfrm>
          <a:prstGeom prst="rect">
            <a:avLst/>
          </a:prstGeom>
          <a:noFill/>
          <a:ln w="0">
            <a:noFill/>
          </a:ln>
        </p:spPr>
        <p:txBody>
          <a:bodyPr lIns="90720" rIns="90720" tIns="45360" bIns="4536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0" y="8831160"/>
            <a:ext cx="3036960" cy="463680"/>
          </a:xfrm>
          <a:prstGeom prst="rect">
            <a:avLst/>
          </a:prstGeom>
          <a:noFill/>
          <a:ln w="0">
            <a:noFill/>
          </a:ln>
        </p:spPr>
        <p:txBody>
          <a:bodyPr lIns="90720" rIns="90720" tIns="45360" bIns="4536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 name="PlaceHolder 6"/>
          <p:cNvSpPr>
            <a:spLocks noGrp="1"/>
          </p:cNvSpPr>
          <p:nvPr>
            <p:ph type="sldNum" idx="6"/>
          </p:nvPr>
        </p:nvSpPr>
        <p:spPr>
          <a:xfrm>
            <a:off x="3971880" y="8831160"/>
            <a:ext cx="3036960" cy="463680"/>
          </a:xfrm>
          <a:prstGeom prst="rect">
            <a:avLst/>
          </a:prstGeom>
          <a:noFill/>
          <a:ln w="0">
            <a:noFill/>
          </a:ln>
        </p:spPr>
        <p:txBody>
          <a:bodyPr lIns="90720" rIns="90720" tIns="45360" bIns="4536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E60DB37-B7A3-4F15-BCD8-83EBD5CDDE84}"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2" name="PlaceHolder 1"/>
          <p:cNvSpPr>
            <a:spLocks noGrp="1"/>
          </p:cNvSpPr>
          <p:nvPr>
            <p:ph type="sldImg"/>
          </p:nvPr>
        </p:nvSpPr>
        <p:spPr>
          <a:xfrm>
            <a:off x="1179360" y="696960"/>
            <a:ext cx="4651560" cy="3487680"/>
          </a:xfrm>
          <a:prstGeom prst="rect">
            <a:avLst/>
          </a:prstGeom>
          <a:ln w="0">
            <a:noFill/>
          </a:ln>
        </p:spPr>
      </p:sp>
      <p:sp>
        <p:nvSpPr>
          <p:cNvPr id="53" name="PlaceHolder 2"/>
          <p:cNvSpPr>
            <a:spLocks noGrp="1"/>
          </p:cNvSpPr>
          <p:nvPr>
            <p:ph type="body"/>
          </p:nvPr>
        </p:nvSpPr>
        <p:spPr>
          <a:xfrm>
            <a:off x="701280" y="4416120"/>
            <a:ext cx="5607000" cy="418284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54" name="Slide Number Placeholder 3"/>
          <p:cNvSpPr/>
          <p:nvPr/>
        </p:nvSpPr>
        <p:spPr>
          <a:xfrm>
            <a:off x="3971880" y="8831160"/>
            <a:ext cx="3036960" cy="463680"/>
          </a:xfrm>
          <a:prstGeom prst="rect">
            <a:avLst/>
          </a:prstGeom>
          <a:noFill/>
          <a:ln w="0">
            <a:noFill/>
          </a:ln>
        </p:spPr>
        <p:style>
          <a:lnRef idx="0"/>
          <a:fillRef idx="0"/>
          <a:effectRef idx="0"/>
          <a:fontRef idx="minor"/>
        </p:style>
        <p:txBody>
          <a:bodyPr lIns="90720" rIns="90720" tIns="45360" bIns="4536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9F9489B-F173-4D09-AD90-6FA4072C018B}"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ACBB059-F2C6-45FB-9628-27D6CDA6E8D6}"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D05C884-22DF-4022-8552-3FBD785C186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DCF068B-B3A6-4E5F-A247-E53CFC625C0A}"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6D0BCF70-8374-4D2F-88FB-8892753D865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FEAA4C0-6586-435C-9A13-7E35C9D2A15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FC516DC-69F3-48DD-BF67-4A08FB0A4CD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E3B21E7-BE73-4AFF-838F-0B23655AE46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1F58081-2550-4412-B62C-3C695AB3B63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A231B98-FAA7-41AE-AD7C-EAE631AF4ED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BDD6C50-F1CB-4985-A8A3-7E077419891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6A55268-D66C-4EF4-9475-1981B53F96E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5E7709C-25E3-4804-BFFA-92195D64792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BED35D2-905F-444D-AB5F-75DB397C5E45}"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Slide Number Placeholder 2"/>
          <p:cNvSpPr/>
          <p:nvPr/>
        </p:nvSpPr>
        <p:spPr>
          <a:xfrm>
            <a:off x="6553080" y="6356520"/>
            <a:ext cx="2133720" cy="365040"/>
          </a:xfrm>
          <a:prstGeom prst="rect">
            <a:avLst/>
          </a:prstGeom>
          <a:noFill/>
          <a:ln w="0">
            <a:noFill/>
          </a:ln>
        </p:spPr>
        <p:style>
          <a:lnRef idx="0"/>
          <a:fillRef idx="0"/>
          <a:effectRef idx="0"/>
          <a:fontRef idx="minor"/>
        </p:style>
        <p:txBody>
          <a:bodyPr lIns="90000" rIns="90000" tIns="46800" bIns="46800" anchor="ctr">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3812B5C-499A-4DC5-A492-1829AE696406}"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graphicFrame>
        <p:nvGraphicFramePr>
          <p:cNvPr id="49" name=""/>
          <p:cNvGraphicFramePr/>
          <p:nvPr/>
        </p:nvGraphicFramePr>
        <p:xfrm>
          <a:off x="177840" y="754200"/>
          <a:ext cx="8661240" cy="5190840"/>
        </p:xfrm>
        <a:graphic>
          <a:graphicData uri="http://schemas.openxmlformats.org/drawingml/2006/table">
            <a:tbl>
              <a:tblPr/>
              <a:tblGrid>
                <a:gridCol w="520560"/>
                <a:gridCol w="1435320"/>
                <a:gridCol w="799920"/>
                <a:gridCol w="836640"/>
                <a:gridCol w="541440"/>
                <a:gridCol w="541440"/>
                <a:gridCol w="838080"/>
                <a:gridCol w="838080"/>
                <a:gridCol w="541440"/>
                <a:gridCol w="541440"/>
                <a:gridCol w="1226880"/>
              </a:tblGrid>
              <a:tr h="490320">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Gene</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Full Name</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Normalized Median </a:t>
                      </a:r>
                      <a:endParaRPr b="0" lang="en-US" sz="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CEFT + </a:t>
                      </a:r>
                      <a:endParaRPr b="0" lang="en-US" sz="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Isotype</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Normalized Median </a:t>
                      </a:r>
                      <a:endParaRPr b="0" lang="en-US" sz="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CEFT + </a:t>
                      </a:r>
                      <a:endParaRPr b="0" lang="en-US" sz="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Anti-PD-L1</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Paired Wilcoxon </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Fold Change </a:t>
                      </a:r>
                      <a:endParaRPr b="0" lang="en-US" sz="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Median)</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Normalized Median </a:t>
                      </a:r>
                      <a:endParaRPr b="0" lang="en-US" sz="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CEFT + </a:t>
                      </a:r>
                      <a:endParaRPr b="0" lang="en-US" sz="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Isotype</a:t>
                      </a:r>
                      <a:endParaRPr b="0" lang="en-US" sz="800" spc="-1" strike="noStrike">
                        <a:solidFill>
                          <a:srgbClr val="000000"/>
                        </a:solidFill>
                        <a:latin typeface="Calibri"/>
                      </a:endParaRPr>
                    </a:p>
                  </a:txBody>
                  <a:tcPr anchor="ctr" marL="3600" marR="3600">
                    <a:lnL w="9360">
                      <a:solidFill>
                        <a:srgbClr val="000000"/>
                      </a:solidFill>
                    </a:lnL>
                    <a:lnR w="5760">
                      <a:solidFill>
                        <a:srgbClr val="000000"/>
                      </a:solidFill>
                    </a:lnR>
                    <a:lnT w="5760">
                      <a:solidFill>
                        <a:srgbClr val="000000"/>
                      </a:solidFill>
                    </a:lnT>
                    <a:lnB w="5760">
                      <a:solidFill>
                        <a:srgbClr val="000000"/>
                      </a:solidFill>
                    </a:lnB>
                    <a:noFill/>
                  </a:tcPr>
                </a:tc>
                <a:tc>
                  <a:txBody>
                    <a:bodyPr lIns="3600" rIns="3600" tIns="360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Normalized Median </a:t>
                      </a:r>
                      <a:endParaRPr b="0" lang="en-US" sz="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CEFT + </a:t>
                      </a:r>
                      <a:endParaRPr b="0" lang="en-US" sz="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Anti-PD-L1</a:t>
                      </a:r>
                      <a:endParaRPr b="0" lang="en-US" sz="800" spc="-1" strike="noStrike">
                        <a:solidFill>
                          <a:srgbClr val="000000"/>
                        </a:solidFill>
                        <a:latin typeface="Calibri"/>
                      </a:endParaRPr>
                    </a:p>
                  </a:txBody>
                  <a:tcPr anchor="ctr" marL="3600" marR="360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Paired Wilcoxon </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Fold Change </a:t>
                      </a:r>
                      <a:endParaRPr b="0" lang="en-US" sz="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Median)</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Annotation</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r>
              <a:tr h="249480">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TNFRSF10B</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TRAIL receptor 2 </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35</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6.46</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550</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4.80</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4.45</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3.67</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9203</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21</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nduces apoptosis upon ligand binding</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r>
              <a:tr h="614160">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C1QBP</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Calibri"/>
                        </a:rPr>
                        <a:t>Complement component 1, q subcomponent binding protein</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45</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9.90</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048</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4.04</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3.40</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3.53</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9154</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04</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Sub component of the first component of the serum complement system, P32 subunit of pre-mrNA splicing factor SF2</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r>
              <a:tr h="247680">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ABCB1</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ATP binding cassette subfamily B member 1</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3.29</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2.40</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278</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3.77</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1.09</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0.92</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5137</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02</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D243, CD molecules</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r>
              <a:tr h="247680">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TFRC</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Transferrin receptor</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5.03</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5.53</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421</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3.09</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7.28</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3.96</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2300</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84</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CD71, CD molecules, iron receptor</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r>
              <a:tr h="493560">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TARP</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TCR gamma alternate reading frame protein</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36</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4.10</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415</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3.02</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42</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27</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7975</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60</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TCR gamma alternate reading frame protein, found in some populations of mature T-cells</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r>
              <a:tr h="125640">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SIGIRR</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Single Ig IL-1-related receptor</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7.94</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8.62</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473</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35</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7.61</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2.61</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4539</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22</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nnate immune response</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r>
              <a:tr h="369720">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ICAM2</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ntercellular adhesion molecule 2 </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53</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3.17</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475</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2.07</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3.43</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77</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9757</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94</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Adhesion, CD molecules, regulation of immune response</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r>
              <a:tr h="127080">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FOXP3</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Forkhead box P3</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36</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99</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541</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86</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05</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31</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609</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24</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T-cell mediated immunity</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r>
              <a:tr h="247680">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ITGA5</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ntegrin alpha-5</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4.31</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7.77</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988</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81</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5.34</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6.26</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8851</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17</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800" spc="-1" strike="noStrike">
                          <a:solidFill>
                            <a:srgbClr val="000000"/>
                          </a:solidFill>
                          <a:latin typeface="Calibri"/>
                        </a:rPr>
                        <a:t>Adhesion, CD49e, innate immune response</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r>
              <a:tr h="371520">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IFNL2</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800" spc="-1" strike="noStrike">
                          <a:solidFill>
                            <a:srgbClr val="000000"/>
                          </a:solidFill>
                          <a:latin typeface="Calibri"/>
                        </a:rPr>
                        <a:t>Interferon, lambda 2, Interluekin 28A</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29</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64</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250</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74</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12</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72</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442</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54</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Promotes anti-viral response and activates the NFKB pathway</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r>
              <a:tr h="247680">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NRP1</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Neuropilin-1</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29</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68</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457</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26</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12</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31</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9521</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17</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Basic cell functions, CD 304, VEGF co-receptor</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r>
              <a:tr h="369720">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HMGB1</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High mobility group box 1</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36</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68</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468</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24</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05</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19</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1895</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13</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Inflammatory response to antigenic stimulus, Innate immune response</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r>
              <a:tr h="370080">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FCGR3A</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Low affinity immunoglobulin gamma Fc region receptor III-A  (CD16-A)</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36</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68</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176</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24</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05</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31</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832</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24</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Subunit of CD16</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r>
              <a:tr h="371160">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CCR5</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C chemokine receptor type 5</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36</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68</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176</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22</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05</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31</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832</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24</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D molecules, cytokines and receptors, T-cell polarization</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r>
              <a:tr h="247680">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Calibri"/>
                        </a:rPr>
                        <a:t>TPTE</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Transmembrane phosphatase with tensin homology</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30</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60</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0023</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20</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99</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33</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0.1359</a:t>
                      </a:r>
                      <a:endParaRPr b="0" lang="en-US" sz="800" spc="-1" strike="noStrike">
                        <a:solidFill>
                          <a:srgbClr val="000000"/>
                        </a:solidFill>
                        <a:latin typeface="Calibri"/>
                      </a:endParaRPr>
                    </a:p>
                  </a:txBody>
                  <a:tcPr anchor="ctr" marL="4320" marR="4320">
                    <a:lnL w="5760">
                      <a:solidFill>
                        <a:srgbClr val="000000"/>
                      </a:solidFill>
                    </a:lnL>
                    <a:lnR w="57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1.50</a:t>
                      </a:r>
                      <a:endParaRPr b="0" lang="en-US" sz="800" spc="-1" strike="noStrike">
                        <a:solidFill>
                          <a:srgbClr val="000000"/>
                        </a:solidFill>
                        <a:latin typeface="Calibri"/>
                      </a:endParaRPr>
                    </a:p>
                  </a:txBody>
                  <a:tcPr anchor="ctr" marL="4320" marR="4320">
                    <a:lnL w="5760">
                      <a:solidFill>
                        <a:srgbClr val="000000"/>
                      </a:solidFill>
                    </a:lnL>
                    <a:lnR w="9360">
                      <a:solidFill>
                        <a:srgbClr val="000000"/>
                      </a:solidFill>
                    </a:lnR>
                    <a:lnT w="5760">
                      <a:solidFill>
                        <a:srgbClr val="000000"/>
                      </a:solidFill>
                    </a:lnT>
                    <a:lnB w="5760">
                      <a:solidFill>
                        <a:srgbClr val="000000"/>
                      </a:solidFill>
                    </a:lnB>
                    <a:noFill/>
                  </a:tcPr>
                </a:tc>
                <a:tc>
                  <a:txBody>
                    <a:bodyPr lIns="4320" rIns="4320" tIns="43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rPr>
                        <a:t>CT antigen</a:t>
                      </a:r>
                      <a:endParaRPr b="0" lang="en-US" sz="800" spc="-1" strike="noStrike">
                        <a:solidFill>
                          <a:srgbClr val="000000"/>
                        </a:solidFill>
                        <a:latin typeface="Calibri"/>
                      </a:endParaRPr>
                    </a:p>
                  </a:txBody>
                  <a:tcPr anchor="ctr" marL="4320" marR="4320">
                    <a:lnL w="93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
        <p:nvSpPr>
          <p:cNvPr id="50" name="PlaceHolder 1"/>
          <p:cNvSpPr>
            <a:spLocks noGrp="1"/>
          </p:cNvSpPr>
          <p:nvPr>
            <p:ph type="title"/>
          </p:nvPr>
        </p:nvSpPr>
        <p:spPr>
          <a:xfrm>
            <a:off x="151920" y="42480"/>
            <a:ext cx="8534520" cy="609480"/>
          </a:xfrm>
          <a:prstGeom prst="rect">
            <a:avLst/>
          </a:prstGeom>
          <a:noFill/>
          <a:ln w="0">
            <a:noFill/>
          </a:ln>
        </p:spPr>
        <p:txBody>
          <a:bodyPr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upplementary Table 2</a:t>
            </a:r>
            <a:br>
              <a:rPr sz="1200"/>
            </a:br>
            <a:r>
              <a:rPr b="1" lang="en-US" sz="1200" spc="-1" strike="noStrike">
                <a:solidFill>
                  <a:srgbClr val="000000"/>
                </a:solidFill>
                <a:latin typeface="Calibri"/>
              </a:rPr>
              <a:t>Upregulated genes in PBMCs from healthy donors stimulated with CEFT or HLA peptide pools and treated with anti-PD-L1 (avelumab) compared to the isotype control </a:t>
            </a:r>
            <a:endParaRPr b="0" lang="en-US" sz="1200" spc="-1" strike="noStrike">
              <a:solidFill>
                <a:srgbClr val="000000"/>
              </a:solidFill>
              <a:latin typeface="Calibri"/>
            </a:endParaRPr>
          </a:p>
        </p:txBody>
      </p:sp>
      <p:sp>
        <p:nvSpPr>
          <p:cNvPr id="51" name="TextBox 4"/>
          <p:cNvSpPr/>
          <p:nvPr/>
        </p:nvSpPr>
        <p:spPr>
          <a:xfrm>
            <a:off x="152280" y="5981760"/>
            <a:ext cx="8763120" cy="8240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Arial"/>
              </a:rPr>
              <a:t>Notable immune-related genes identified with trends of differential expression (</a:t>
            </a:r>
            <a:r>
              <a:rPr b="0" i="1" lang="en-US" sz="1200" spc="-1" strike="noStrike">
                <a:solidFill>
                  <a:srgbClr val="000000"/>
                </a:solidFill>
                <a:latin typeface="Calibri"/>
                <a:ea typeface="Arial"/>
              </a:rPr>
              <a:t>P</a:t>
            </a:r>
            <a:r>
              <a:rPr b="0" lang="en-US" sz="1200" spc="-1" strike="noStrike">
                <a:solidFill>
                  <a:srgbClr val="000000"/>
                </a:solidFill>
                <a:latin typeface="Calibri"/>
                <a:ea typeface="Arial"/>
              </a:rPr>
              <a:t> &lt; 0.1 and sorted by fold change) between PBMCs of healthy donors stimulated with CEFT and treated with avelumab relative to the isotype control.  Values for PBMCs stimulated with negative control peptide pool, HLA, and treated with avelumab or the isotype control are also shown. Includes gene name, full name, </a:t>
            </a:r>
            <a:r>
              <a:rPr b="0" i="1" lang="en-US" sz="1200" spc="-1" strike="noStrike">
                <a:solidFill>
                  <a:srgbClr val="000000"/>
                </a:solidFill>
                <a:latin typeface="Calibri"/>
                <a:ea typeface="Arial"/>
              </a:rPr>
              <a:t>P</a:t>
            </a:r>
            <a:r>
              <a:rPr b="0" lang="en-US" sz="1200" spc="-1" strike="noStrike">
                <a:solidFill>
                  <a:srgbClr val="000000"/>
                </a:solidFill>
                <a:latin typeface="Calibri"/>
                <a:ea typeface="Arial"/>
              </a:rPr>
              <a:t> value, fold change, and annotated function.</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042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04-23T20:58:24Z</dcterms:created>
  <dc:creator>Grenga, Italia (NIH/NCI) [F]</dc:creator>
  <dc:description/>
  <dc:language>en-US</dc:language>
  <cp:lastModifiedBy>Weingarten, Debra (NIH/NCI) [E]</cp:lastModifiedBy>
  <cp:lastPrinted>2016-03-29T19:01:01Z</cp:lastPrinted>
  <dcterms:modified xsi:type="dcterms:W3CDTF">2016-04-06T19:08:26Z</dcterms:modified>
  <cp:revision>145</cp:revision>
  <dc:subject/>
  <dc:title>Comparison between EMD Serono a-PDL1 and commercially available a-PDL1</dc:title>
</cp:coreProperties>
</file>